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8204"/>
    <a:srgbClr val="0472C1"/>
    <a:srgbClr val="018001"/>
    <a:srgbClr val="5EFFFF"/>
    <a:srgbClr val="CC6600"/>
    <a:srgbClr val="7030A0"/>
    <a:srgbClr val="FF0606"/>
    <a:srgbClr val="FF01FF"/>
    <a:srgbClr val="A020EF"/>
    <a:srgbClr val="17FF1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874" y="15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118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251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931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5937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1707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6429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2414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339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503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357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602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BBFEC2-190D-46C5-B8F7-07E68E49FFC8}" type="datetimeFigureOut">
              <a:rPr lang="en-US" smtClean="0"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D3E03-6DF1-4B2A-890D-50A916C4423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2886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71"/>
          <p:cNvPicPr>
            <a:picLocks noChangeAspect="1"/>
          </p:cNvPicPr>
          <p:nvPr/>
        </p:nvPicPr>
        <p:blipFill rotWithShape="1">
          <a:blip r:embed="rId2"/>
          <a:srcRect l="2443"/>
          <a:stretch/>
        </p:blipFill>
        <p:spPr>
          <a:xfrm>
            <a:off x="8567738" y="3826447"/>
            <a:ext cx="1838854" cy="2978025"/>
          </a:xfrm>
          <a:prstGeom prst="rect">
            <a:avLst/>
          </a:prstGeom>
        </p:spPr>
      </p:pic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3"/>
          <a:srcRect l="1853" r="-1"/>
          <a:stretch/>
        </p:blipFill>
        <p:spPr>
          <a:xfrm>
            <a:off x="6581775" y="3827152"/>
            <a:ext cx="1849984" cy="2967469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4"/>
          <a:srcRect l="1773" r="191"/>
          <a:stretch/>
        </p:blipFill>
        <p:spPr>
          <a:xfrm>
            <a:off x="4648200" y="3829000"/>
            <a:ext cx="1847850" cy="2978025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 rotWithShape="1">
          <a:blip r:embed="rId5"/>
          <a:srcRect l="1913"/>
          <a:stretch/>
        </p:blipFill>
        <p:spPr>
          <a:xfrm>
            <a:off x="2698750" y="3827152"/>
            <a:ext cx="1848850" cy="2978025"/>
          </a:xfrm>
          <a:prstGeom prst="rect">
            <a:avLst/>
          </a:prstGeom>
        </p:spPr>
      </p:pic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6"/>
          <a:srcRect r="732"/>
          <a:stretch/>
        </p:blipFill>
        <p:spPr>
          <a:xfrm>
            <a:off x="630340" y="3827152"/>
            <a:ext cx="1884893" cy="2978025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7"/>
          <a:srcRect l="2506" r="370"/>
          <a:stretch/>
        </p:blipFill>
        <p:spPr>
          <a:xfrm>
            <a:off x="8595360" y="714995"/>
            <a:ext cx="1830706" cy="2963927"/>
          </a:xfrm>
          <a:prstGeom prst="rect">
            <a:avLst/>
          </a:prstGeom>
        </p:spPr>
      </p:pic>
      <p:pic>
        <p:nvPicPr>
          <p:cNvPr id="58" name="Picture 57"/>
          <p:cNvPicPr>
            <a:picLocks noChangeAspect="1"/>
          </p:cNvPicPr>
          <p:nvPr/>
        </p:nvPicPr>
        <p:blipFill rotWithShape="1">
          <a:blip r:embed="rId8"/>
          <a:srcRect l="1059" r="1"/>
          <a:stretch/>
        </p:blipFill>
        <p:spPr>
          <a:xfrm>
            <a:off x="6591299" y="719600"/>
            <a:ext cx="1864921" cy="2954209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 rotWithShape="1">
          <a:blip r:embed="rId9"/>
          <a:srcRect l="2420" r="691" b="321"/>
          <a:stretch/>
        </p:blipFill>
        <p:spPr>
          <a:xfrm>
            <a:off x="4660899" y="729714"/>
            <a:ext cx="1826261" cy="2937411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 rotWithShape="1">
          <a:blip r:embed="rId10"/>
          <a:srcRect l="2323" r="652"/>
          <a:stretch/>
        </p:blipFill>
        <p:spPr>
          <a:xfrm>
            <a:off x="2692400" y="710236"/>
            <a:ext cx="1828800" cy="2978025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11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648122" y="703446"/>
            <a:ext cx="1884894" cy="2978025"/>
          </a:xfrm>
          <a:prstGeom prst="rect">
            <a:avLst/>
          </a:prstGeom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10977336" y="2272839"/>
            <a:ext cx="12105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5EFF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cerevisiae</a:t>
            </a:r>
            <a:endParaRPr lang="en-US" sz="1400" i="1" dirty="0">
              <a:solidFill>
                <a:srgbClr val="5EFF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947260" y="2533700"/>
            <a:ext cx="12394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CC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paradoxus</a:t>
            </a:r>
            <a:endParaRPr lang="en-US" sz="1400" i="1" dirty="0">
              <a:solidFill>
                <a:srgbClr val="CC66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1159888" y="2817711"/>
            <a:ext cx="10310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01800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mikatae</a:t>
            </a:r>
            <a:endParaRPr lang="en-US" sz="1400" i="1" dirty="0">
              <a:solidFill>
                <a:srgbClr val="01800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844885" y="3101672"/>
            <a:ext cx="1340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0472C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kudriavzevii</a:t>
            </a:r>
            <a:endParaRPr lang="en-US" sz="1400" i="1" dirty="0">
              <a:solidFill>
                <a:srgbClr val="0472C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996588" y="3381762"/>
            <a:ext cx="11897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FF01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arboricola</a:t>
            </a:r>
            <a:endParaRPr lang="en-US" sz="1400" i="1" dirty="0">
              <a:solidFill>
                <a:srgbClr val="FF01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1184364" y="3656070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FF06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uvarum</a:t>
            </a:r>
            <a:endParaRPr lang="en-US" sz="1400" i="1" dirty="0">
              <a:solidFill>
                <a:srgbClr val="FF060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906571" y="3943300"/>
            <a:ext cx="12795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i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eubayanus</a:t>
            </a:r>
            <a:endParaRPr lang="en-US" sz="1400" i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758623" y="-16070"/>
            <a:ext cx="54648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Maximum specific growth rate (µ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72"/>
          <p:cNvCxnSpPr/>
          <p:nvPr/>
        </p:nvCxnSpPr>
        <p:spPr>
          <a:xfrm flipV="1">
            <a:off x="644957" y="1680673"/>
            <a:ext cx="9779000" cy="834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V="1">
            <a:off x="644957" y="2691226"/>
            <a:ext cx="9779000" cy="1180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tangle 77"/>
          <p:cNvSpPr/>
          <p:nvPr/>
        </p:nvSpPr>
        <p:spPr>
          <a:xfrm>
            <a:off x="736143" y="697446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9" name="Rectangle 78"/>
          <p:cNvSpPr/>
          <p:nvPr/>
        </p:nvSpPr>
        <p:spPr>
          <a:xfrm>
            <a:off x="2709803" y="697446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/>
          <p:cNvSpPr/>
          <p:nvPr/>
        </p:nvSpPr>
        <p:spPr>
          <a:xfrm>
            <a:off x="4661716" y="696627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/>
          <p:cNvSpPr/>
          <p:nvPr/>
        </p:nvSpPr>
        <p:spPr>
          <a:xfrm>
            <a:off x="6590060" y="694614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Rectangle 81"/>
          <p:cNvSpPr/>
          <p:nvPr/>
        </p:nvSpPr>
        <p:spPr>
          <a:xfrm>
            <a:off x="8583075" y="694613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/>
          <p:cNvSpPr/>
          <p:nvPr/>
        </p:nvSpPr>
        <p:spPr>
          <a:xfrm>
            <a:off x="736143" y="4101936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/>
          <p:cNvSpPr/>
          <p:nvPr/>
        </p:nvSpPr>
        <p:spPr>
          <a:xfrm>
            <a:off x="2709803" y="4101936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/>
          <p:cNvSpPr/>
          <p:nvPr/>
        </p:nvSpPr>
        <p:spPr>
          <a:xfrm>
            <a:off x="4661716" y="4101117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/>
          <p:cNvSpPr/>
          <p:nvPr/>
        </p:nvSpPr>
        <p:spPr>
          <a:xfrm>
            <a:off x="6590060" y="4099104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/>
          <p:cNvSpPr/>
          <p:nvPr/>
        </p:nvSpPr>
        <p:spPr>
          <a:xfrm>
            <a:off x="8583075" y="4099103"/>
            <a:ext cx="1790700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96" name="Straight Connector 95"/>
          <p:cNvCxnSpPr/>
          <p:nvPr/>
        </p:nvCxnSpPr>
        <p:spPr>
          <a:xfrm flipV="1">
            <a:off x="645257" y="4798706"/>
            <a:ext cx="9779000" cy="834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 flipV="1">
            <a:off x="640495" y="5813242"/>
            <a:ext cx="9779000" cy="1180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97"/>
          <p:cNvSpPr txBox="1"/>
          <p:nvPr/>
        </p:nvSpPr>
        <p:spPr>
          <a:xfrm>
            <a:off x="51727" y="1527048"/>
            <a:ext cx="609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9325" y="2547756"/>
            <a:ext cx="609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1281" y="3490488"/>
            <a:ext cx="609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16622" y="4641260"/>
            <a:ext cx="609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1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14220" y="5665951"/>
            <a:ext cx="609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16176" y="6618843"/>
            <a:ext cx="6092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0.00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991479" y="323466"/>
            <a:ext cx="12800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2518903" y="315630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 All H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4484159" y="322794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6421592" y="329025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etamid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8400126" y="334115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umaroyl amid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94593" y="3733985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erulic aci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589273" y="3738531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M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4496810" y="3725249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eruloyl amid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6397898" y="3725561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i="1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umaric</a:t>
            </a:r>
            <a:endParaRPr lang="en-US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8372731" y="3708923"/>
            <a:ext cx="21887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odium acetat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 flipV="1">
            <a:off x="641373" y="6765753"/>
            <a:ext cx="9779000" cy="1180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flipV="1">
            <a:off x="679400" y="3631761"/>
            <a:ext cx="9779000" cy="11806"/>
          </a:xfrm>
          <a:prstGeom prst="line">
            <a:avLst/>
          </a:prstGeom>
          <a:ln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10639893" y="4217608"/>
            <a:ext cx="15488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ynthetic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ybrids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260888" y="2173022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143807" y="217302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870371" y="217352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97980" y="2172779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371863" y="217277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612253" y="217272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838088" y="217352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2060208" y="217099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4310576" y="17575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052525" y="1757580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2874339" y="175808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594328" y="1757337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299631" y="1757337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543831" y="1757285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849676" y="175808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083226" y="175555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8196008" y="1068466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7025587" y="106846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6792156" y="106896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6475020" y="1000937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7251720" y="998432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,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7409578" y="1144371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7756063" y="106896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7961038" y="1066442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10134852" y="1062611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9050156" y="106261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8814820" y="106311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8456704" y="1062368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9251542" y="1062368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9491932" y="1062316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9738722" y="106311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9936077" y="106058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6246103" y="859935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,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5125212" y="85993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4884161" y="8604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4525115" y="792406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,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5385653" y="85969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5626043" y="8596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5851878" y="8604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6011133" y="857911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2252942" y="422134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1135861" y="422134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904335" y="422184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580509" y="4221098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333437" y="4221098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552872" y="4297246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1824427" y="422184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973522" y="4219317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4253120" y="4375751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3160804" y="437575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2933088" y="43762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2590212" y="4375508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3385050" y="4375508"/>
            <a:ext cx="32252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3572100" y="4375456"/>
            <a:ext cx="40908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,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3872230" y="437625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4054345" y="437372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6272397" y="42107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5114041" y="421074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4883785" y="42112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4591709" y="421050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5340827" y="421050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>
            <a:off x="5525972" y="428665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>
            <a:off x="5807687" y="421125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6038062" y="42087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8214175" y="428038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7043754" y="428038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6810323" y="42808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6518882" y="428013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7279430" y="42801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7519820" y="428008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7762800" y="42808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3" name="TextBox 192"/>
          <p:cNvSpPr txBox="1"/>
          <p:nvPr/>
        </p:nvSpPr>
        <p:spPr>
          <a:xfrm>
            <a:off x="7981110" y="42783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10134549" y="431043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8975597" y="431132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8789752" y="431094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8507836" y="4310195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9251239" y="43101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9480199" y="431014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9734609" y="431094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9911009" y="430841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,b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65472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133</Words>
  <Application>Microsoft Office PowerPoint</Application>
  <PresentationFormat>Widescreen</PresentationFormat>
  <Paragraphs>1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VE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50</cp:revision>
  <dcterms:created xsi:type="dcterms:W3CDTF">2015-12-08T23:03:30Z</dcterms:created>
  <dcterms:modified xsi:type="dcterms:W3CDTF">2017-02-23T22:06:26Z</dcterms:modified>
</cp:coreProperties>
</file>